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Ex1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8" r:id="rId2"/>
    <p:sldId id="256" r:id="rId3"/>
    <p:sldId id="260" r:id="rId4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08000"/>
    <a:srgbClr val="3333FF"/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83" autoAdjust="0"/>
    <p:restoredTop sz="94434" autoAdjust="0"/>
  </p:normalViewPr>
  <p:slideViewPr>
    <p:cSldViewPr snapToGrid="0">
      <p:cViewPr>
        <p:scale>
          <a:sx n="274" d="100"/>
          <a:sy n="274" d="100"/>
        </p:scale>
        <p:origin x="-1620" y="-579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509701\Desktop\aerosol&#35542;&#25991;\&#12456;&#12450;&#12525;&#12478;&#12523;16S\trim_17_21_300_270\LEfSe\level6_relative_valu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C:\Users\509701\Desktop\aerosol&#35542;&#25991;\&#12456;&#12450;&#12525;&#12478;&#12523;16S\trim_17_21_300_270\core-metrics-results\metadata.tsv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Sheet11 (2)'!$A$3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3:$D$3</c:f>
              <c:numCache>
                <c:formatCode>0.0_ </c:formatCode>
                <c:ptCount val="3"/>
                <c:pt idx="0">
                  <c:v>21.050103103333299</c:v>
                </c:pt>
                <c:pt idx="1">
                  <c:v>17.583036214285713</c:v>
                </c:pt>
                <c:pt idx="2">
                  <c:v>19.24941342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E6-44FB-9471-EBDACC84026D}"/>
            </c:ext>
          </c:extLst>
        </c:ser>
        <c:ser>
          <c:idx val="1"/>
          <c:order val="1"/>
          <c:tx>
            <c:strRef>
              <c:f>'Sheet11 (2)'!$A$4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4:$D$4</c:f>
              <c:numCache>
                <c:formatCode>0.0_ </c:formatCode>
                <c:ptCount val="3"/>
                <c:pt idx="0">
                  <c:v>14.604459110000001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E6-44FB-9471-EBDACC84026D}"/>
            </c:ext>
          </c:extLst>
        </c:ser>
        <c:ser>
          <c:idx val="2"/>
          <c:order val="2"/>
          <c:tx>
            <c:strRef>
              <c:f>'Sheet11 (2)'!$A$5</c:f>
              <c:strCache>
                <c:ptCount val="1"/>
                <c:pt idx="0">
                  <c:v>Methylobacteriu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5:$D$5</c:f>
              <c:numCache>
                <c:formatCode>0.0_ </c:formatCode>
                <c:ptCount val="3"/>
                <c:pt idx="0">
                  <c:v>1.5686538800000001</c:v>
                </c:pt>
                <c:pt idx="1">
                  <c:v>2.5676659285714294</c:v>
                </c:pt>
                <c:pt idx="2">
                  <c:v>1.42871317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4E6-44FB-9471-EBDACC84026D}"/>
            </c:ext>
          </c:extLst>
        </c:ser>
        <c:ser>
          <c:idx val="3"/>
          <c:order val="3"/>
          <c:tx>
            <c:strRef>
              <c:f>'Sheet11 (2)'!$A$6</c:f>
              <c:strCache>
                <c:ptCount val="1"/>
                <c:pt idx="0">
                  <c:v>Pseudomona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6:$D$6</c:f>
              <c:numCache>
                <c:formatCode>0.0_ </c:formatCode>
                <c:ptCount val="3"/>
                <c:pt idx="0">
                  <c:v>1.3720205499999998</c:v>
                </c:pt>
                <c:pt idx="1">
                  <c:v>5.4465650523809552</c:v>
                </c:pt>
                <c:pt idx="2">
                  <c:v>2.28677680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4E6-44FB-9471-EBDACC84026D}"/>
            </c:ext>
          </c:extLst>
        </c:ser>
        <c:ser>
          <c:idx val="4"/>
          <c:order val="4"/>
          <c:tx>
            <c:strRef>
              <c:f>'Sheet11 (2)'!$A$7</c:f>
              <c:strCache>
                <c:ptCount val="1"/>
                <c:pt idx="0">
                  <c:v>Vibrio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7:$D$7</c:f>
              <c:numCache>
                <c:formatCode>0.0_ </c:formatCode>
                <c:ptCount val="3"/>
                <c:pt idx="0">
                  <c:v>1.2333374666666665</c:v>
                </c:pt>
                <c:pt idx="1">
                  <c:v>3.867302890476191</c:v>
                </c:pt>
                <c:pt idx="2">
                  <c:v>1.07902933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4E6-44FB-9471-EBDACC84026D}"/>
            </c:ext>
          </c:extLst>
        </c:ser>
        <c:ser>
          <c:idx val="5"/>
          <c:order val="5"/>
          <c:tx>
            <c:strRef>
              <c:f>'Sheet11 (2)'!$A$8</c:f>
              <c:strCache>
                <c:ptCount val="1"/>
                <c:pt idx="0">
                  <c:v>Arthrobacter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8:$D$8</c:f>
              <c:numCache>
                <c:formatCode>0.0_ </c:formatCode>
                <c:ptCount val="3"/>
                <c:pt idx="0">
                  <c:v>1.0806349566666666</c:v>
                </c:pt>
                <c:pt idx="1">
                  <c:v>1.6169958952380954</c:v>
                </c:pt>
                <c:pt idx="2">
                  <c:v>3.81621085333333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4E6-44FB-9471-EBDACC84026D}"/>
            </c:ext>
          </c:extLst>
        </c:ser>
        <c:ser>
          <c:idx val="6"/>
          <c:order val="6"/>
          <c:tx>
            <c:strRef>
              <c:f>'Sheet11 (2)'!$A$9</c:f>
              <c:strCache>
                <c:ptCount val="1"/>
                <c:pt idx="0">
                  <c:v>Roseomona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9:$D$9</c:f>
              <c:numCache>
                <c:formatCode>0.0_ </c:formatCode>
                <c:ptCount val="3"/>
                <c:pt idx="0">
                  <c:v>1.0142657199999996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4E6-44FB-9471-EBDACC84026D}"/>
            </c:ext>
          </c:extLst>
        </c:ser>
        <c:ser>
          <c:idx val="7"/>
          <c:order val="7"/>
          <c:tx>
            <c:strRef>
              <c:f>'Sheet11 (2)'!$A$10</c:f>
              <c:strCache>
                <c:ptCount val="1"/>
                <c:pt idx="0">
                  <c:v>Craurococcu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0:$D$10</c:f>
              <c:numCache>
                <c:formatCode>0.0_ </c:formatCode>
                <c:ptCount val="3"/>
                <c:pt idx="0">
                  <c:v>1.0098573633333334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4E6-44FB-9471-EBDACC84026D}"/>
            </c:ext>
          </c:extLst>
        </c:ser>
        <c:ser>
          <c:idx val="8"/>
          <c:order val="8"/>
          <c:tx>
            <c:strRef>
              <c:f>'Sheet11 (2)'!$A$11</c:f>
              <c:strCache>
                <c:ptCount val="1"/>
                <c:pt idx="0">
                  <c:v>Ralstoni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1:$D$11</c:f>
              <c:numCache>
                <c:formatCode>0.0_ </c:formatCode>
                <c:ptCount val="3"/>
                <c:pt idx="0">
                  <c:v>0.96840338666666659</c:v>
                </c:pt>
                <c:pt idx="1">
                  <c:v>0</c:v>
                </c:pt>
                <c:pt idx="2">
                  <c:v>3.09588414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4E6-44FB-9471-EBDACC84026D}"/>
            </c:ext>
          </c:extLst>
        </c:ser>
        <c:ser>
          <c:idx val="9"/>
          <c:order val="9"/>
          <c:tx>
            <c:strRef>
              <c:f>'Sheet11 (2)'!$A$12</c:f>
              <c:strCache>
                <c:ptCount val="1"/>
                <c:pt idx="0">
                  <c:v>Achromobacter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2:$D$12</c:f>
              <c:numCache>
                <c:formatCode>0.0_ </c:formatCode>
                <c:ptCount val="3"/>
                <c:pt idx="0">
                  <c:v>0.83295424000000007</c:v>
                </c:pt>
                <c:pt idx="1">
                  <c:v>1.539334142857143</c:v>
                </c:pt>
                <c:pt idx="2">
                  <c:v>5.02916668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4E6-44FB-9471-EBDACC84026D}"/>
            </c:ext>
          </c:extLst>
        </c:ser>
        <c:ser>
          <c:idx val="10"/>
          <c:order val="10"/>
          <c:tx>
            <c:strRef>
              <c:f>'Sheet11 (2)'!$A$13</c:f>
              <c:strCache>
                <c:ptCount val="1"/>
                <c:pt idx="0">
                  <c:v>Methylococcus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3:$D$13</c:f>
              <c:numCache>
                <c:formatCode>0.0_ </c:formatCode>
                <c:ptCount val="3"/>
                <c:pt idx="0">
                  <c:v>0</c:v>
                </c:pt>
                <c:pt idx="1">
                  <c:v>4.2750584666666658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4E6-44FB-9471-EBDACC84026D}"/>
            </c:ext>
          </c:extLst>
        </c:ser>
        <c:ser>
          <c:idx val="11"/>
          <c:order val="11"/>
          <c:tx>
            <c:strRef>
              <c:f>'Sheet11 (2)'!$A$14</c:f>
              <c:strCache>
                <c:ptCount val="1"/>
                <c:pt idx="0">
                  <c:v>Acinetobacter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4:$D$14</c:f>
              <c:numCache>
                <c:formatCode>0.0_ </c:formatCode>
                <c:ptCount val="3"/>
                <c:pt idx="0">
                  <c:v>0</c:v>
                </c:pt>
                <c:pt idx="1">
                  <c:v>3.0184739190476191</c:v>
                </c:pt>
                <c:pt idx="2">
                  <c:v>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4E6-44FB-9471-EBDACC84026D}"/>
            </c:ext>
          </c:extLst>
        </c:ser>
        <c:ser>
          <c:idx val="12"/>
          <c:order val="12"/>
          <c:tx>
            <c:strRef>
              <c:f>'Sheet11 (2)'!$A$15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5:$D$15</c:f>
              <c:numCache>
                <c:formatCode>0.0_ </c:formatCode>
                <c:ptCount val="3"/>
                <c:pt idx="0">
                  <c:v>0</c:v>
                </c:pt>
                <c:pt idx="1">
                  <c:v>2.7877242380952381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4E6-44FB-9471-EBDACC84026D}"/>
            </c:ext>
          </c:extLst>
        </c:ser>
        <c:ser>
          <c:idx val="13"/>
          <c:order val="13"/>
          <c:tx>
            <c:strRef>
              <c:f>'Sheet11 (2)'!$A$16</c:f>
              <c:strCache>
                <c:ptCount val="1"/>
                <c:pt idx="0">
                  <c:v>Acidovorax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6:$D$16</c:f>
              <c:numCache>
                <c:formatCode>0.0_ </c:formatCode>
                <c:ptCount val="3"/>
                <c:pt idx="0">
                  <c:v>0</c:v>
                </c:pt>
                <c:pt idx="1">
                  <c:v>1.5567082238095236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4E6-44FB-9471-EBDACC84026D}"/>
            </c:ext>
          </c:extLst>
        </c:ser>
        <c:ser>
          <c:idx val="14"/>
          <c:order val="14"/>
          <c:tx>
            <c:strRef>
              <c:f>'Sheet11 (2)'!$A$17</c:f>
              <c:strCache>
                <c:ptCount val="1"/>
                <c:pt idx="0">
                  <c:v>Lactobacillus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7:$D$17</c:f>
              <c:numCache>
                <c:formatCode>0.0_ 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75547571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24E6-44FB-9471-EBDACC84026D}"/>
            </c:ext>
          </c:extLst>
        </c:ser>
        <c:ser>
          <c:idx val="15"/>
          <c:order val="15"/>
          <c:tx>
            <c:strRef>
              <c:f>'Sheet11 (2)'!$A$18</c:f>
              <c:strCache>
                <c:ptCount val="1"/>
                <c:pt idx="0">
                  <c:v>Ochrobactrum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8:$D$18</c:f>
              <c:numCache>
                <c:formatCode>0.0_ 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26858426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24E6-44FB-9471-EBDACC84026D}"/>
            </c:ext>
          </c:extLst>
        </c:ser>
        <c:ser>
          <c:idx val="16"/>
          <c:order val="16"/>
          <c:tx>
            <c:strRef>
              <c:f>'Sheet11 (2)'!$A$19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19:$D$19</c:f>
              <c:numCache>
                <c:formatCode>0.0_ </c:formatCode>
                <c:ptCount val="3"/>
                <c:pt idx="0">
                  <c:v>22.902507679999999</c:v>
                </c:pt>
                <c:pt idx="1">
                  <c:v>31.930984080952364</c:v>
                </c:pt>
                <c:pt idx="2">
                  <c:v>25.005071859999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4E6-44FB-9471-EBDACC84026D}"/>
            </c:ext>
          </c:extLst>
        </c:ser>
        <c:ser>
          <c:idx val="17"/>
          <c:order val="17"/>
          <c:tx>
            <c:strRef>
              <c:f>'Sheet11 (2)'!$A$20</c:f>
              <c:strCache>
                <c:ptCount val="1"/>
                <c:pt idx="0">
                  <c:v>Not assigne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Sheet11 (2)'!$B$2:$D$2</c:f>
              <c:strCache>
                <c:ptCount val="3"/>
                <c:pt idx="0">
                  <c:v>Road (N = 30)</c:v>
                </c:pt>
                <c:pt idx="1">
                  <c:v>Bathroom (N = 21)</c:v>
                </c:pt>
                <c:pt idx="2">
                  <c:v>Indoor site (N = 30)</c:v>
                </c:pt>
              </c:strCache>
            </c:strRef>
          </c:cat>
          <c:val>
            <c:numRef>
              <c:f>'Sheet11 (2)'!$B$20:$D$20</c:f>
              <c:numCache>
                <c:formatCode>0.0_ </c:formatCode>
                <c:ptCount val="3"/>
                <c:pt idx="0">
                  <c:v>32.362803079999999</c:v>
                </c:pt>
                <c:pt idx="1">
                  <c:v>23.810149728571432</c:v>
                </c:pt>
                <c:pt idx="2">
                  <c:v>34.78383027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24E6-44FB-9471-EBDACC8402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63045632"/>
        <c:axId val="463047272"/>
      </c:barChart>
      <c:catAx>
        <c:axId val="463045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63047272"/>
        <c:crosses val="autoZero"/>
        <c:auto val="1"/>
        <c:lblAlgn val="ctr"/>
        <c:lblOffset val="100"/>
        <c:noMultiLvlLbl val="0"/>
      </c:catAx>
      <c:valAx>
        <c:axId val="463047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63045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7972263343244302E-2"/>
          <c:y val="0.74152027234305573"/>
          <c:w val="0.96825555941771091"/>
          <c:h val="0.24359281552030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1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metadata (3)'!$F$4:$F$33</cx:f>
        <cx:lvl ptCount="30" formatCode="G/標準">
          <cx:pt idx="0">23.811466188499999</cx:pt>
          <cx:pt idx="1">42.091357546499999</cx:pt>
          <cx:pt idx="2">67.860292466499999</cx:pt>
          <cx:pt idx="3">16.9696155205</cx:pt>
          <cx:pt idx="4">23.263597672500001</cx:pt>
          <cx:pt idx="5">16.849074285499999</cx:pt>
          <cx:pt idx="6">73.494606297499999</cx:pt>
          <cx:pt idx="7">34.626206258499998</cx:pt>
          <cx:pt idx="8">34.480278341499996</cx:pt>
          <cx:pt idx="9">40.523918028499999</cx:pt>
          <cx:pt idx="10">25.018665011500001</cx:pt>
          <cx:pt idx="11">32.7563006245</cx:pt>
          <cx:pt idx="12">42.376219453499999</cx:pt>
          <cx:pt idx="13">39.936190742500003</cx:pt>
          <cx:pt idx="14">28.157688824499999</cx:pt>
          <cx:pt idx="15">38.290285496499997</cx:pt>
          <cx:pt idx="16">52.576079575500003</cx:pt>
          <cx:pt idx="17">36.599666569500002</cx:pt>
          <cx:pt idx="18">34.172501327500001</cx:pt>
          <cx:pt idx="19">43.480965048500003</cx:pt>
          <cx:pt idx="20">38.552129621500001</cx:pt>
          <cx:pt idx="21">42.486416963499998</cx:pt>
          <cx:pt idx="22">3.7769467835000001</cx:pt>
          <cx:pt idx="23">4.5437403485000001</cx:pt>
          <cx:pt idx="24">6.4438143595000001</cx:pt>
          <cx:pt idx="25">4.2982079935000002</cx:pt>
          <cx:pt idx="26">4.5521675545000004</cx:pt>
          <cx:pt idx="27">39.298296334500002</cx:pt>
          <cx:pt idx="28">65.914122217499994</cx:pt>
          <cx:pt idx="29">48.164534701500003</cx:pt>
        </cx:lvl>
      </cx:numDim>
    </cx:data>
    <cx:data id="1">
      <cx:numDim type="val">
        <cx:f>'metadata (3)'!$F$34:$F$54</cx:f>
        <cx:lvl ptCount="21" formatCode="G/標準">
          <cx:pt idx="0">27.715221276499999</cx:pt>
          <cx:pt idx="1">41.187795038499999</cx:pt>
          <cx:pt idx="2">34.908018675500003</cx:pt>
          <cx:pt idx="3">46.401974483499998</cx:pt>
          <cx:pt idx="4">38.165110050499997</cx:pt>
          <cx:pt idx="5">46.627123890500002</cx:pt>
          <cx:pt idx="6">14.6726910755</cx:pt>
          <cx:pt idx="7">30.7097897825</cx:pt>
          <cx:pt idx="8">25.839411023499999</cx:pt>
          <cx:pt idx="9">25.843294218499999</cx:pt>
          <cx:pt idx="10">38.444531824499997</cx:pt>
          <cx:pt idx="11">31.187459587500001</cx:pt>
          <cx:pt idx="12">46.427919930999998</cx:pt>
          <cx:pt idx="13">41.004257708499999</cx:pt>
          <cx:pt idx="14">24.888430419500001</cx:pt>
          <cx:pt idx="15">59.091731278499999</cx:pt>
          <cx:pt idx="16">24.951303863500002</cx:pt>
          <cx:pt idx="17">18.856868350500001</cx:pt>
          <cx:pt idx="18">4.4893425134999996</cx:pt>
          <cx:pt idx="19">3.5769604644999999</cx:pt>
          <cx:pt idx="20">5.0114715634999998</cx:pt>
        </cx:lvl>
      </cx:numDim>
    </cx:data>
    <cx:data id="2">
      <cx:numDim type="val">
        <cx:f>'metadata (3)'!$F$55:$F$84</cx:f>
        <cx:lvl ptCount="30" formatCode="G/標準">
          <cx:pt idx="0">3.5740441165000001</cx:pt>
          <cx:pt idx="1">3.5740441165000001</cx:pt>
          <cx:pt idx="2">7.6738564115000001</cx:pt>
          <cx:pt idx="3">7.8762869784999996</cx:pt>
          <cx:pt idx="4">20.0600164835</cx:pt>
          <cx:pt idx="5">19.391497807499999</cx:pt>
          <cx:pt idx="6">23.415244146500001</cx:pt>
          <cx:pt idx="7">10.5762565695</cx:pt>
          <cx:pt idx="8">10.3248459025</cx:pt>
          <cx:pt idx="9">9.8080766515000004</cx:pt>
          <cx:pt idx="10">36.025116029499998</cx:pt>
          <cx:pt idx="11">33.240374592499997</cx:pt>
          <cx:pt idx="12">41.072726211499997</cx:pt>
          <cx:pt idx="13">36.243278375499997</cx:pt>
          <cx:pt idx="14">26.280962043500001</cx:pt>
          <cx:pt idx="15">25.327490464499999</cx:pt>
          <cx:pt idx="16">27.7031664145</cx:pt>
          <cx:pt idx="17">33.3617030005</cx:pt>
          <cx:pt idx="18">36.857407394500001</cx:pt>
          <cx:pt idx="19">23.991996546500001</cx:pt>
          <cx:pt idx="20">20.8510689955</cx:pt>
          <cx:pt idx="21">41.072606515499999</cx:pt>
          <cx:pt idx="22">48.957760520500003</cx:pt>
          <cx:pt idx="23">20.014503166499999</cx:pt>
          <cx:pt idx="24">15.7467959835</cx:pt>
          <cx:pt idx="25">17.921564699499999</cx:pt>
          <cx:pt idx="26">27.8031150465</cx:pt>
          <cx:pt idx="27">33.508217450499998</cx:pt>
          <cx:pt idx="28">16.7560119585</cx:pt>
          <cx:pt idx="29">11.997165256500001</cx:pt>
        </cx:lvl>
      </cx:numDim>
    </cx:data>
  </cx:chartData>
  <cx:chart>
    <cx:plotArea>
      <cx:plotAreaRegion>
        <cx:series layoutId="boxWhisker" uniqueId="{42827767-BE4F-4472-BD40-65904B73026E}">
          <cx:tx>
            <cx:txData>
              <cx:f>'metadata (3)'!$I$1</cx:f>
              <cx:v>Road (N = 30)</cx:v>
            </cx:txData>
          </cx:tx>
          <cx:spPr>
            <a:noFill/>
            <a:ln w="19050">
              <a:solidFill>
                <a:srgbClr val="3333FF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00000001-B304-41D9-BB73-7E50FB92BC99}">
          <cx:tx>
            <cx:txData>
              <cx:f>'metadata (3)'!$I$2</cx:f>
              <cx:v>Bathroom (N = 21)</cx:v>
            </cx:txData>
          </cx:tx>
          <cx:spPr>
            <a:noFill/>
            <a:ln w="19050">
              <a:solidFill>
                <a:srgbClr val="FF0000"/>
              </a:solidFill>
            </a:ln>
          </cx:spPr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00000002-B304-41D9-BB73-7E50FB92BC99}">
          <cx:tx>
            <cx:txData>
              <cx:f>'metadata (3)'!$I$3</cx:f>
              <cx:v>Indoor site (N = 30)</cx:v>
            </cx:txData>
          </cx:tx>
          <cx:spPr>
            <a:noFill/>
            <a:ln w="19050">
              <a:solidFill>
                <a:srgbClr val="008000"/>
              </a:solidFill>
            </a:ln>
          </cx:spPr>
          <cx:dataId val="2"/>
          <cx:layoutPr>
            <cx:visibility nonoutliers="0"/>
            <cx:statistics quartileMethod="exclusive"/>
          </cx:layoutPr>
        </cx:series>
      </cx:plotAreaRegion>
      <cx:axis id="0">
        <cx:catScaling gapWidth="0.5"/>
        <cx:tickLabels/>
        <cx:spPr>
          <a:ln w="12700">
            <a:solidFill>
              <a:schemeClr val="tx1"/>
            </a:solidFill>
          </a:ln>
        </cx:spPr>
        <cx:txPr>
          <a:bodyPr rot="-60000000" spcFirstLastPara="1" vertOverflow="ellipsis" vert="horz" wrap="square" lIns="0" tIns="0" rIns="0" bIns="0" anchor="ctr" anchorCtr="1"/>
          <a:lstStyle/>
          <a:p>
            <a:pPr>
              <a:defRPr>
                <a:ln>
                  <a:noFill/>
                </a:ln>
                <a:noFill/>
              </a:defRPr>
            </a:pPr>
            <a:endParaRPr lang="ja-JP">
              <a:ln>
                <a:noFill/>
              </a:ln>
              <a:noFill/>
            </a:endParaRPr>
          </a:p>
        </cx:txPr>
      </cx:axis>
      <cx:axis id="1">
        <cx:valScaling/>
        <cx:majorTickMarks type="in"/>
        <cx:tickLabels/>
        <cx:spPr>
          <a:ln w="12700">
            <a:solidFill>
              <a:schemeClr val="tx1"/>
            </a:solidFill>
          </a:ln>
        </cx:spPr>
        <cx:txPr>
          <a:bodyPr rot="-60000000" spcFirstLastPara="1" vertOverflow="ellipsis" vert="horz" wrap="square" lIns="0" tIns="0" rIns="0" bIns="0" anchor="ctr" anchorCtr="1"/>
          <a:lstStyle/>
          <a:p>
            <a:pPr>
              <a:defRPr sz="1600">
                <a:noFill/>
              </a:defRPr>
            </a:pPr>
            <a:endParaRPr lang="ja-JP" sz="1600">
              <a:noFill/>
            </a:endParaRPr>
          </a:p>
        </cx:txPr>
      </cx:axis>
    </cx:plotArea>
  </cx:chart>
  <cx:spPr>
    <a:solidFill>
      <a:schemeClr val="bg1"/>
    </a:solidFill>
    <a:ln>
      <a:solidFill>
        <a:schemeClr val="bg1"/>
      </a:solidFill>
    </a:ln>
  </cx:spPr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2E1535-5FD7-4DCB-9442-58DD7724F20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AA8E9F-05E4-4917-B063-0152FA619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55324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AA8E9F-05E4-4917-B063-0152FA61971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06319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AA8E9F-05E4-4917-B063-0152FA61971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97685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AA8E9F-05E4-4917-B063-0152FA61971C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9925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4003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9780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514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29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800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280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08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836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536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094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120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AC417C-9806-4653-B46C-F29E7F54BEB8}" type="datetimeFigureOut">
              <a:rPr kumimoji="1" lang="ja-JP" altLang="en-US" smtClean="0"/>
              <a:t>2021/6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00AC4-982B-44DE-B830-53AA01A09A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109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0667648"/>
              </p:ext>
            </p:extLst>
          </p:nvPr>
        </p:nvGraphicFramePr>
        <p:xfrm>
          <a:off x="214726" y="2373547"/>
          <a:ext cx="6331988" cy="39605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710976" y="8652360"/>
            <a:ext cx="255452" cy="267187"/>
          </a:xfrm>
          <a:prstGeom prst="rect">
            <a:avLst/>
          </a:prstGeom>
          <a:noFill/>
        </p:spPr>
        <p:txBody>
          <a:bodyPr wrap="none" lIns="89978" tIns="44989" rIns="89978" bIns="44989" rtlCol="0">
            <a:spAutoFit/>
          </a:bodyPr>
          <a:lstStyle/>
          <a:p>
            <a:r>
              <a:rPr lang="en-US" altLang="ja-JP" sz="1146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11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951845" y="6676936"/>
            <a:ext cx="485775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axonomic composition</a:t>
            </a:r>
          </a:p>
          <a:p>
            <a:pPr>
              <a:lnSpc>
                <a:spcPct val="200000"/>
              </a:lnSpc>
            </a:pPr>
            <a:r>
              <a:rPr lang="en-US" altLang="ja-JP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xonomic compositi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bacterial reads at the genus level in air samples.</a:t>
            </a:r>
          </a:p>
        </p:txBody>
      </p:sp>
    </p:spTree>
    <p:extLst>
      <p:ext uri="{BB962C8B-B14F-4D97-AF65-F5344CB8AC3E}">
        <p14:creationId xmlns:p14="http://schemas.microsoft.com/office/powerpoint/2010/main" val="3591872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24" name="グラフ 23"/>
              <p:cNvGraphicFramePr/>
              <p:nvPr>
                <p:extLst>
                  <p:ext uri="{D42A27DB-BD31-4B8C-83A1-F6EECF244321}">
                    <p14:modId xmlns:p14="http://schemas.microsoft.com/office/powerpoint/2010/main" val="1605229426"/>
                  </p:ext>
                </p:extLst>
              </p:nvPr>
            </p:nvGraphicFramePr>
            <p:xfrm>
              <a:off x="2218602" y="3162430"/>
              <a:ext cx="1620000" cy="2160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>
          <p:pic>
            <p:nvPicPr>
              <p:cNvPr id="24" name="グラフ 23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218602" y="3162430"/>
                <a:ext cx="1620000" cy="2160000"/>
              </a:xfrm>
              <a:prstGeom prst="rect">
                <a:avLst/>
              </a:prstGeom>
            </p:spPr>
          </p:pic>
        </mc:Fallback>
      </mc:AlternateContent>
      <p:sp>
        <p:nvSpPr>
          <p:cNvPr id="15" name="右大かっこ 14"/>
          <p:cNvSpPr/>
          <p:nvPr/>
        </p:nvSpPr>
        <p:spPr>
          <a:xfrm rot="16200000">
            <a:off x="3152332" y="3148448"/>
            <a:ext cx="72000" cy="468000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710976" y="8652360"/>
            <a:ext cx="255452" cy="267187"/>
          </a:xfrm>
          <a:prstGeom prst="rect">
            <a:avLst/>
          </a:prstGeom>
          <a:noFill/>
        </p:spPr>
        <p:txBody>
          <a:bodyPr wrap="none" lIns="89978" tIns="44989" rIns="89978" bIns="44989" rtlCol="0">
            <a:spAutoFit/>
          </a:bodyPr>
          <a:lstStyle/>
          <a:p>
            <a:r>
              <a:rPr lang="en-US" altLang="ja-JP" sz="1146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1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 rot="5400000" flipH="1" flipV="1">
            <a:off x="1069319" y="3586797"/>
            <a:ext cx="2157555" cy="429411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pha-diversity measure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2244899" y="3094136"/>
            <a:ext cx="450882" cy="377858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244899" y="3493440"/>
            <a:ext cx="450882" cy="377858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244899" y="3892744"/>
            <a:ext cx="450882" cy="377858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2244899" y="4292048"/>
            <a:ext cx="450882" cy="377858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244899" y="4691351"/>
            <a:ext cx="450882" cy="377858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2" name="テキスト ボックス 81"/>
          <p:cNvSpPr txBox="1"/>
          <p:nvPr/>
        </p:nvSpPr>
        <p:spPr>
          <a:xfrm rot="18182252" flipH="1">
            <a:off x="1929942" y="5291524"/>
            <a:ext cx="1364059" cy="429411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ad (N = 30)</a:t>
            </a:r>
          </a:p>
        </p:txBody>
      </p:sp>
      <p:sp>
        <p:nvSpPr>
          <p:cNvPr id="83" name="テキスト ボックス 82"/>
          <p:cNvSpPr txBox="1"/>
          <p:nvPr/>
        </p:nvSpPr>
        <p:spPr>
          <a:xfrm rot="18182252" flipH="1">
            <a:off x="2212389" y="5291524"/>
            <a:ext cx="1364059" cy="429411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hroom (N = 21)</a:t>
            </a:r>
          </a:p>
        </p:txBody>
      </p:sp>
      <p:sp>
        <p:nvSpPr>
          <p:cNvPr id="84" name="テキスト ボックス 83"/>
          <p:cNvSpPr txBox="1"/>
          <p:nvPr/>
        </p:nvSpPr>
        <p:spPr>
          <a:xfrm rot="18182252" flipH="1">
            <a:off x="2468025" y="5291524"/>
            <a:ext cx="1364059" cy="429411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oor site (N = 30)</a:t>
            </a: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2709913" y="3148754"/>
            <a:ext cx="933504" cy="282191"/>
          </a:xfrm>
          <a:prstGeom prst="rect">
            <a:avLst/>
          </a:prstGeom>
          <a:noFill/>
        </p:spPr>
        <p:txBody>
          <a:bodyPr wrap="square" lIns="89978" tIns="44989" rIns="89978" bIns="44989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正方形/長方形 17"/>
          <p:cNvSpPr/>
          <p:nvPr/>
        </p:nvSpPr>
        <p:spPr>
          <a:xfrm>
            <a:off x="951845" y="6676936"/>
            <a:ext cx="485775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pha diversity</a:t>
            </a:r>
          </a:p>
          <a:p>
            <a:pPr>
              <a:lnSpc>
                <a:spcPct val="200000"/>
              </a:lnSpc>
            </a:pP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pha diversity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es in air samples based on Faith’s phylogenetic diversity. 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llis test with th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jamin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ochberg FDR correction).</a:t>
            </a:r>
          </a:p>
        </p:txBody>
      </p:sp>
    </p:spTree>
    <p:extLst>
      <p:ext uri="{BB962C8B-B14F-4D97-AF65-F5344CB8AC3E}">
        <p14:creationId xmlns:p14="http://schemas.microsoft.com/office/powerpoint/2010/main" val="1625699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21343"/>
            <a:ext cx="6858000" cy="4339094"/>
          </a:xfrm>
          <a:prstGeom prst="rect">
            <a:avLst/>
          </a:prstGeom>
        </p:spPr>
      </p:pic>
      <p:sp>
        <p:nvSpPr>
          <p:cNvPr id="6" name="楕円 2"/>
          <p:cNvSpPr/>
          <p:nvPr/>
        </p:nvSpPr>
        <p:spPr>
          <a:xfrm>
            <a:off x="5170864" y="2016218"/>
            <a:ext cx="108000" cy="108000"/>
          </a:xfrm>
          <a:prstGeom prst="ellipse">
            <a:avLst/>
          </a:prstGeom>
          <a:solidFill>
            <a:srgbClr val="3333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1"/>
          <p:cNvSpPr txBox="1"/>
          <p:nvPr/>
        </p:nvSpPr>
        <p:spPr>
          <a:xfrm>
            <a:off x="5260756" y="1930813"/>
            <a:ext cx="898340" cy="54839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ad</a:t>
            </a:r>
            <a:r>
              <a:rPr lang="en-US" altLang="ja-JP" sz="105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5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30)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1"/>
          <p:cNvSpPr txBox="1"/>
          <p:nvPr/>
        </p:nvSpPr>
        <p:spPr>
          <a:xfrm>
            <a:off x="5260756" y="2322833"/>
            <a:ext cx="956249" cy="48868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throom</a:t>
            </a:r>
            <a:r>
              <a:rPr lang="en-US" altLang="ja-JP" sz="105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5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21)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1"/>
          <p:cNvSpPr txBox="1"/>
          <p:nvPr/>
        </p:nvSpPr>
        <p:spPr>
          <a:xfrm>
            <a:off x="5260756" y="2717126"/>
            <a:ext cx="959716" cy="4339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oor site</a:t>
            </a:r>
            <a:r>
              <a:rPr lang="en-US" altLang="ja-JP" sz="105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5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30)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楕円 6"/>
          <p:cNvSpPr/>
          <p:nvPr/>
        </p:nvSpPr>
        <p:spPr>
          <a:xfrm>
            <a:off x="5170864" y="2387493"/>
            <a:ext cx="108000" cy="108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楕円 7"/>
          <p:cNvSpPr/>
          <p:nvPr/>
        </p:nvSpPr>
        <p:spPr>
          <a:xfrm>
            <a:off x="5170864" y="2799228"/>
            <a:ext cx="108000" cy="108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10976" y="8652360"/>
            <a:ext cx="255452" cy="267187"/>
          </a:xfrm>
          <a:prstGeom prst="rect">
            <a:avLst/>
          </a:prstGeom>
          <a:noFill/>
        </p:spPr>
        <p:txBody>
          <a:bodyPr wrap="none" lIns="89978" tIns="44989" rIns="89978" bIns="44989" rtlCol="0">
            <a:spAutoFit/>
          </a:bodyPr>
          <a:lstStyle/>
          <a:p>
            <a:r>
              <a:rPr lang="en-US" altLang="ja-JP" sz="1146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14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966428" y="6355312"/>
            <a:ext cx="485775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Beta diversity</a:t>
            </a:r>
          </a:p>
          <a:p>
            <a:pPr>
              <a:lnSpc>
                <a:spcPct val="200000"/>
              </a:lnSpc>
            </a:pP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a diversity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weighted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Fra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ances shows overall variation in the bacterial community. A total of 81 air samples from roads (N = 30), bathrooms (N = 21), and other indoor sites (N = 30) were plotted with three dimensions. </a:t>
            </a:r>
          </a:p>
        </p:txBody>
      </p:sp>
    </p:spTree>
    <p:extLst>
      <p:ext uri="{BB962C8B-B14F-4D97-AF65-F5344CB8AC3E}">
        <p14:creationId xmlns:p14="http://schemas.microsoft.com/office/powerpoint/2010/main" val="1651271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2</TotalTime>
  <Words>158</Words>
  <Application>Microsoft Office PowerPoint</Application>
  <PresentationFormat>A4 210 x 297 mm</PresentationFormat>
  <Paragraphs>28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>情報政策課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富山県</dc:creator>
  <cp:lastModifiedBy>富山県</cp:lastModifiedBy>
  <cp:revision>91</cp:revision>
  <cp:lastPrinted>2019-11-15T06:26:20Z</cp:lastPrinted>
  <dcterms:created xsi:type="dcterms:W3CDTF">2019-11-15T05:05:59Z</dcterms:created>
  <dcterms:modified xsi:type="dcterms:W3CDTF">2021-06-08T04:01:50Z</dcterms:modified>
</cp:coreProperties>
</file>